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2" r:id="rId2"/>
    <p:sldId id="256" r:id="rId3"/>
    <p:sldId id="263" r:id="rId4"/>
    <p:sldId id="259" r:id="rId5"/>
    <p:sldId id="261" r:id="rId6"/>
    <p:sldId id="258" r:id="rId7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2382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0000"/>
    <p:restoredTop sz="92678"/>
  </p:normalViewPr>
  <p:slideViewPr>
    <p:cSldViewPr snapToGrid="0" snapToObjects="1">
      <p:cViewPr varScale="1">
        <p:scale>
          <a:sx n="111" d="100"/>
          <a:sy n="111" d="100"/>
        </p:scale>
        <p:origin x="5288" y="20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071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738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078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589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486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999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591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500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982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192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92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4438F-BCAE-304E-ABD1-7172B1395E90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1F293-14FD-DD49-8593-874ED46D5F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03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77C16C0-3B09-DE42-B07B-3D38669298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0" y="1054100"/>
            <a:ext cx="6477000" cy="80899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4403B2B-BF81-8846-A05B-96D3CAE0D22C}"/>
              </a:ext>
            </a:extLst>
          </p:cNvPr>
          <p:cNvSpPr txBox="1"/>
          <p:nvPr/>
        </p:nvSpPr>
        <p:spPr>
          <a:xfrm>
            <a:off x="1" y="0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S1. </a:t>
            </a:r>
            <a:r>
              <a:rPr lang="en-US" sz="1200" dirty="0">
                <a:latin typeface="Helvetica" pitchFamily="2" charset="0"/>
              </a:rPr>
              <a:t>Quality control metrics for 20 OC H3K27ac </a:t>
            </a:r>
            <a:r>
              <a:rPr lang="en-US" sz="1200" dirty="0" err="1">
                <a:latin typeface="Helvetica" pitchFamily="2" charset="0"/>
              </a:rPr>
              <a:t>ChIP-seq</a:t>
            </a:r>
            <a:r>
              <a:rPr lang="en-US" sz="1200" dirty="0">
                <a:latin typeface="Helvetica" pitchFamily="2" charset="0"/>
              </a:rPr>
              <a:t> profiles: (a) number of reads, (b) normalized strand cross-correlation coefficient (NSC) and relative strand cross-correlation coefficient (RSC), (c) fraction of reads in peaks (</a:t>
            </a:r>
            <a:r>
              <a:rPr lang="en-US" sz="1200" dirty="0" err="1">
                <a:latin typeface="Helvetica" pitchFamily="2" charset="0"/>
              </a:rPr>
              <a:t>FRiP</a:t>
            </a:r>
            <a:r>
              <a:rPr lang="en-US" sz="1200" dirty="0">
                <a:latin typeface="Helvetica" pitchFamily="2" charset="0"/>
              </a:rPr>
              <a:t>); and summary of peak calling results: (d) number of peaks, (e) genome coverage, (f) number of reads vs. number of peaks, (g) number of reads vs. genome coverage and (h) number of peaks vs. genome coverage.</a:t>
            </a:r>
          </a:p>
        </p:txBody>
      </p:sp>
    </p:spTree>
    <p:extLst>
      <p:ext uri="{BB962C8B-B14F-4D97-AF65-F5344CB8AC3E}">
        <p14:creationId xmlns:p14="http://schemas.microsoft.com/office/powerpoint/2010/main" val="11672515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6DB6F9C8-577B-1C47-88DF-B431FEA48B72}"/>
              </a:ext>
            </a:extLst>
          </p:cNvPr>
          <p:cNvGrpSpPr/>
          <p:nvPr/>
        </p:nvGrpSpPr>
        <p:grpSpPr>
          <a:xfrm>
            <a:off x="4781871" y="6493132"/>
            <a:ext cx="1343637" cy="2217699"/>
            <a:chOff x="5373380" y="6926301"/>
            <a:chExt cx="1343637" cy="2217699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D6A5CE8-44FA-7740-8CFD-172A973205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38800" y="7480300"/>
              <a:ext cx="812800" cy="16637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E3F544C-473A-C14A-B382-2C117D9C2AA9}"/>
                </a:ext>
              </a:extLst>
            </p:cNvPr>
            <p:cNvSpPr txBox="1"/>
            <p:nvPr/>
          </p:nvSpPr>
          <p:spPr>
            <a:xfrm>
              <a:off x="5373380" y="6926301"/>
              <a:ext cx="1343637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sz="1200" dirty="0">
                  <a:latin typeface="Helvetica" pitchFamily="2" charset="0"/>
                </a:rPr>
                <a:t>Gene expression</a:t>
              </a:r>
            </a:p>
            <a:p>
              <a:pPr algn="ctr"/>
              <a:r>
                <a:rPr lang="en-US" sz="1200" dirty="0">
                  <a:latin typeface="Helvetica" pitchFamily="2" charset="0"/>
                </a:rPr>
                <a:t>z-score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28509C6-8810-0540-A2D0-145EF975A9E4}"/>
              </a:ext>
            </a:extLst>
          </p:cNvPr>
          <p:cNvGrpSpPr/>
          <p:nvPr/>
        </p:nvGrpSpPr>
        <p:grpSpPr>
          <a:xfrm>
            <a:off x="457200" y="457200"/>
            <a:ext cx="5943600" cy="5943600"/>
            <a:chOff x="914400" y="0"/>
            <a:chExt cx="5943600" cy="59436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3E3DED4-6AEC-A64E-A5A0-5413F2D16AD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14400" y="0"/>
              <a:ext cx="5943600" cy="594360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016AAA1-A825-0140-B255-3EBB24F9BC33}"/>
                </a:ext>
              </a:extLst>
            </p:cNvPr>
            <p:cNvSpPr txBox="1"/>
            <p:nvPr/>
          </p:nvSpPr>
          <p:spPr>
            <a:xfrm>
              <a:off x="982718" y="61486"/>
              <a:ext cx="1513637" cy="158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ctr" anchorCtr="1">
              <a:no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Helvetica" pitchFamily="2" charset="0"/>
                </a:rPr>
                <a:t>CCOC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86C43A4-D918-E544-9EF6-3F0DAC121E66}"/>
                </a:ext>
              </a:extLst>
            </p:cNvPr>
            <p:cNvSpPr txBox="1"/>
            <p:nvPr/>
          </p:nvSpPr>
          <p:spPr>
            <a:xfrm>
              <a:off x="2496354" y="61486"/>
              <a:ext cx="1256219" cy="158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ctr" anchorCtr="1">
              <a:no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  <a:latin typeface="Helvetica" pitchFamily="2" charset="0"/>
                </a:rPr>
                <a:t>EnOC</a:t>
              </a:r>
              <a:endParaRPr lang="en-US" sz="1200" dirty="0">
                <a:solidFill>
                  <a:schemeClr val="bg1"/>
                </a:solidFill>
                <a:latin typeface="Helvetica" pitchFamily="2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13B1479-985B-C149-B078-F83F8DE892D9}"/>
                </a:ext>
              </a:extLst>
            </p:cNvPr>
            <p:cNvSpPr txBox="1"/>
            <p:nvPr/>
          </p:nvSpPr>
          <p:spPr>
            <a:xfrm>
              <a:off x="3752573" y="61486"/>
              <a:ext cx="1513637" cy="158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ctr" anchorCtr="1">
              <a:no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Helvetica" pitchFamily="2" charset="0"/>
                </a:rPr>
                <a:t>HGSO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1C7BF03-03AE-9447-9547-A917E7C8F94E}"/>
                </a:ext>
              </a:extLst>
            </p:cNvPr>
            <p:cNvSpPr txBox="1"/>
            <p:nvPr/>
          </p:nvSpPr>
          <p:spPr>
            <a:xfrm>
              <a:off x="5266210" y="61486"/>
              <a:ext cx="1513637" cy="158496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ctr" anchorCtr="1">
              <a:no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  <a:latin typeface="Helvetica" pitchFamily="2" charset="0"/>
                </a:rPr>
                <a:t>MOC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80FDFECD-8CC0-DC4A-8E57-5557D909ABBE}"/>
              </a:ext>
            </a:extLst>
          </p:cNvPr>
          <p:cNvSpPr txBox="1"/>
          <p:nvPr/>
        </p:nvSpPr>
        <p:spPr>
          <a:xfrm>
            <a:off x="457200" y="149354"/>
            <a:ext cx="45400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S2. </a:t>
            </a:r>
            <a:r>
              <a:rPr lang="en-US" sz="1200" dirty="0" err="1">
                <a:latin typeface="Helvetica" pitchFamily="2" charset="0"/>
              </a:rPr>
              <a:t>Histotype</a:t>
            </a:r>
            <a:r>
              <a:rPr lang="en-US" sz="1200" dirty="0">
                <a:latin typeface="Helvetica" pitchFamily="2" charset="0"/>
              </a:rPr>
              <a:t>-specific gene expression.</a:t>
            </a:r>
          </a:p>
        </p:txBody>
      </p:sp>
    </p:spTree>
    <p:extLst>
      <p:ext uri="{BB962C8B-B14F-4D97-AF65-F5344CB8AC3E}">
        <p14:creationId xmlns:p14="http://schemas.microsoft.com/office/powerpoint/2010/main" val="30520725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6A01ACE-F4AE-104C-8817-7560C68A8C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4291" y="2966013"/>
            <a:ext cx="3110696" cy="31106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E42B616-0688-C045-A11C-C9933AC63969}"/>
              </a:ext>
            </a:extLst>
          </p:cNvPr>
          <p:cNvSpPr txBox="1"/>
          <p:nvPr/>
        </p:nvSpPr>
        <p:spPr>
          <a:xfrm>
            <a:off x="457201" y="149354"/>
            <a:ext cx="59275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S3.</a:t>
            </a:r>
            <a:r>
              <a:rPr lang="en-US" sz="1200" dirty="0">
                <a:latin typeface="Helvetica" pitchFamily="2" charset="0"/>
              </a:rPr>
              <a:t> Average gene expression by </a:t>
            </a:r>
            <a:r>
              <a:rPr lang="en-US" sz="1200" dirty="0" err="1">
                <a:latin typeface="Helvetica" pitchFamily="2" charset="0"/>
              </a:rPr>
              <a:t>histotype</a:t>
            </a:r>
            <a:r>
              <a:rPr lang="en-US" sz="1200" dirty="0">
                <a:latin typeface="Helvetica" pitchFamily="2" charset="0"/>
              </a:rPr>
              <a:t> (CCOC, </a:t>
            </a:r>
            <a:r>
              <a:rPr lang="en-US" sz="1200" dirty="0" err="1">
                <a:latin typeface="Helvetica" pitchFamily="2" charset="0"/>
              </a:rPr>
              <a:t>EnOC</a:t>
            </a:r>
            <a:r>
              <a:rPr lang="en-US" sz="1200" dirty="0">
                <a:latin typeface="Helvetica" pitchFamily="2" charset="0"/>
              </a:rPr>
              <a:t>, HGSOC and MOC) of genes nearby common regulatory elements (REs).</a:t>
            </a:r>
          </a:p>
        </p:txBody>
      </p:sp>
    </p:spTree>
    <p:extLst>
      <p:ext uri="{BB962C8B-B14F-4D97-AF65-F5344CB8AC3E}">
        <p14:creationId xmlns:p14="http://schemas.microsoft.com/office/powerpoint/2010/main" val="24362049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A3EB9BA4-E343-E744-A7FC-67D5685D6159}"/>
              </a:ext>
            </a:extLst>
          </p:cNvPr>
          <p:cNvSpPr txBox="1"/>
          <p:nvPr/>
        </p:nvSpPr>
        <p:spPr>
          <a:xfrm>
            <a:off x="0" y="0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S4.</a:t>
            </a:r>
            <a:r>
              <a:rPr lang="en-US" sz="1200" dirty="0">
                <a:latin typeface="Helvetica" pitchFamily="2" charset="0"/>
              </a:rPr>
              <a:t> Pathways enriched in each gene set associated with</a:t>
            </a:r>
          </a:p>
          <a:p>
            <a:r>
              <a:rPr lang="en-US" sz="1200" dirty="0" err="1">
                <a:latin typeface="Helvetica" pitchFamily="2" charset="0"/>
              </a:rPr>
              <a:t>histotype</a:t>
            </a:r>
            <a:r>
              <a:rPr lang="en-US" sz="1200" dirty="0">
                <a:latin typeface="Helvetica" pitchFamily="2" charset="0"/>
              </a:rPr>
              <a:t>-specific (Fold change &lt; 0; CCOC – red, HGSOC – green, MOC – purple) and EOC common Res (gray).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4A06460C-D3AD-AE4D-988F-9C36DE2EDD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142249" y="368718"/>
            <a:ext cx="4568994" cy="68534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25701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26A4D04-CBDB-6145-A14E-B3F777FE74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7200"/>
            <a:ext cx="6858000" cy="549070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20E7F4D-6AD8-5A48-B6F8-ECDC4CA1B418}"/>
              </a:ext>
            </a:extLst>
          </p:cNvPr>
          <p:cNvSpPr txBox="1"/>
          <p:nvPr/>
        </p:nvSpPr>
        <p:spPr>
          <a:xfrm>
            <a:off x="0" y="0"/>
            <a:ext cx="46522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S5.</a:t>
            </a:r>
            <a:r>
              <a:rPr lang="en-US" sz="1200" dirty="0">
                <a:latin typeface="Helvetica" pitchFamily="2" charset="0"/>
              </a:rPr>
              <a:t> Super enhancer calls in the 20 EOCs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879F06-6F91-B044-AABF-27FE0D1AC92C}"/>
              </a:ext>
            </a:extLst>
          </p:cNvPr>
          <p:cNvSpPr txBox="1"/>
          <p:nvPr/>
        </p:nvSpPr>
        <p:spPr>
          <a:xfrm>
            <a:off x="0" y="39303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a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58074334-1B39-0545-908D-D95B099A213C}"/>
              </a:ext>
            </a:extLst>
          </p:cNvPr>
          <p:cNvGrpSpPr/>
          <p:nvPr/>
        </p:nvGrpSpPr>
        <p:grpSpPr>
          <a:xfrm>
            <a:off x="3516533" y="5947906"/>
            <a:ext cx="2857500" cy="1684421"/>
            <a:chOff x="774344" y="5971840"/>
            <a:chExt cx="2857500" cy="1684421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2ECFDBB-421E-E94D-8622-62B8AC1A3E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842" b="38211"/>
            <a:stretch/>
          </p:blipFill>
          <p:spPr>
            <a:xfrm>
              <a:off x="774344" y="5971840"/>
              <a:ext cx="2857500" cy="1684421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AD77346-3AD4-704A-AECD-BA498E983140}"/>
                </a:ext>
              </a:extLst>
            </p:cNvPr>
            <p:cNvSpPr txBox="1"/>
            <p:nvPr/>
          </p:nvSpPr>
          <p:spPr>
            <a:xfrm>
              <a:off x="774344" y="5971840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Helvetica" pitchFamily="2" charset="0"/>
                </a:rPr>
                <a:t>d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0F65567-3285-234D-98C8-C9CDC0E7D430}"/>
              </a:ext>
            </a:extLst>
          </p:cNvPr>
          <p:cNvGrpSpPr/>
          <p:nvPr/>
        </p:nvGrpSpPr>
        <p:grpSpPr>
          <a:xfrm>
            <a:off x="1474637" y="5948298"/>
            <a:ext cx="1702962" cy="1610362"/>
            <a:chOff x="4026504" y="6065238"/>
            <a:chExt cx="1702962" cy="161036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134B5E7-CFAB-1A41-B117-2EAEEAD315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19104" y="6065238"/>
              <a:ext cx="1610362" cy="1610362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B412A57-51C7-A44C-98AD-5DDFF83F1DF1}"/>
                </a:ext>
              </a:extLst>
            </p:cNvPr>
            <p:cNvSpPr txBox="1"/>
            <p:nvPr/>
          </p:nvSpPr>
          <p:spPr>
            <a:xfrm>
              <a:off x="4026504" y="6065238"/>
              <a:ext cx="2090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Helvetica" pitchFamily="2" charset="0"/>
                </a:rPr>
                <a:t>b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B1A4B4FA-E319-344F-A5CB-C77366A4AEAD}"/>
              </a:ext>
            </a:extLst>
          </p:cNvPr>
          <p:cNvGrpSpPr/>
          <p:nvPr/>
        </p:nvGrpSpPr>
        <p:grpSpPr>
          <a:xfrm>
            <a:off x="1516283" y="7558268"/>
            <a:ext cx="3808071" cy="1493140"/>
            <a:chOff x="1787501" y="7639285"/>
            <a:chExt cx="3808071" cy="1493140"/>
          </a:xfrm>
        </p:grpSpPr>
        <p:pic>
          <p:nvPicPr>
            <p:cNvPr id="19" name="Picture 18" descr="A screenshot of a cell phone&#13;&#10;&#13;&#10;Description automatically generated">
              <a:extLst>
                <a:ext uri="{FF2B5EF4-FFF2-40B4-BE49-F238E27FC236}">
                  <a16:creationId xmlns:a16="http://schemas.microsoft.com/office/drawing/2014/main" id="{991B4D4B-3212-6940-9DAC-FB655EDCBB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473" t="14899" r="5992" b="33196"/>
            <a:stretch/>
          </p:blipFill>
          <p:spPr>
            <a:xfrm>
              <a:off x="1787501" y="7847635"/>
              <a:ext cx="3808071" cy="1284790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1106AA3-CD81-9844-B89E-0501F6FF9534}"/>
                </a:ext>
              </a:extLst>
            </p:cNvPr>
            <p:cNvSpPr txBox="1"/>
            <p:nvPr/>
          </p:nvSpPr>
          <p:spPr>
            <a:xfrm>
              <a:off x="1787501" y="763928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140609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80FDFECD-8CC0-DC4A-8E57-5557D909ABBE}"/>
              </a:ext>
            </a:extLst>
          </p:cNvPr>
          <p:cNvSpPr txBox="1"/>
          <p:nvPr/>
        </p:nvSpPr>
        <p:spPr>
          <a:xfrm>
            <a:off x="236483" y="153929"/>
            <a:ext cx="65649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S6. </a:t>
            </a:r>
            <a:r>
              <a:rPr lang="en-US" sz="1200" dirty="0"/>
              <a:t>(a) Number of single nucleotide variants per sample and (b) distribution of</a:t>
            </a:r>
          </a:p>
          <a:p>
            <a:r>
              <a:rPr lang="en-US" sz="1200" dirty="0"/>
              <a:t>single nucleotide variants by genomic regions: coding, active promoters, active enhancers, nonactive</a:t>
            </a:r>
          </a:p>
          <a:p>
            <a:r>
              <a:rPr lang="en-US" sz="1200" dirty="0"/>
              <a:t>promoters and other noncoding.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ED80B42B-657D-4C46-BC6C-C190597592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9028" y="4693604"/>
            <a:ext cx="3154680" cy="315468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72CB2A9B-579F-4247-9B9D-E097E96982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9028" y="1261925"/>
            <a:ext cx="3154680" cy="3154680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F127FBA5-B140-B24F-92E6-9484D12E6FE6}"/>
              </a:ext>
            </a:extLst>
          </p:cNvPr>
          <p:cNvSpPr txBox="1"/>
          <p:nvPr/>
        </p:nvSpPr>
        <p:spPr>
          <a:xfrm>
            <a:off x="1679028" y="1261925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  <a:endParaRPr lang="en-US" sz="12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8ED81BC-F9C9-0F4B-B767-11FCDE0C6648}"/>
              </a:ext>
            </a:extLst>
          </p:cNvPr>
          <p:cNvSpPr txBox="1"/>
          <p:nvPr/>
        </p:nvSpPr>
        <p:spPr>
          <a:xfrm>
            <a:off x="1679028" y="469360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51971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8</TotalTime>
  <Words>243</Words>
  <Application>Microsoft Macintosh PowerPoint</Application>
  <PresentationFormat>Letter Paper (8.5x11 in)</PresentationFormat>
  <Paragraphs>2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rona de la Fuente, Rosario</dc:creator>
  <cp:lastModifiedBy>Corona de la Fuente, Rosario</cp:lastModifiedBy>
  <cp:revision>29</cp:revision>
  <cp:lastPrinted>2018-10-25T19:45:29Z</cp:lastPrinted>
  <dcterms:created xsi:type="dcterms:W3CDTF">2018-08-06T15:47:16Z</dcterms:created>
  <dcterms:modified xsi:type="dcterms:W3CDTF">2019-02-01T11:43:41Z</dcterms:modified>
</cp:coreProperties>
</file>